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78" r:id="rId3"/>
    <p:sldId id="261" r:id="rId4"/>
    <p:sldId id="264" r:id="rId5"/>
    <p:sldId id="265" r:id="rId6"/>
    <p:sldId id="262" r:id="rId7"/>
    <p:sldId id="259" r:id="rId8"/>
    <p:sldId id="266" r:id="rId9"/>
    <p:sldId id="267" r:id="rId10"/>
    <p:sldId id="268" r:id="rId11"/>
    <p:sldId id="269" r:id="rId12"/>
    <p:sldId id="270" r:id="rId13"/>
    <p:sldId id="271" r:id="rId14"/>
    <p:sldId id="272" r:id="rId15"/>
    <p:sldId id="273" r:id="rId16"/>
    <p:sldId id="274" r:id="rId17"/>
    <p:sldId id="275" r:id="rId18"/>
    <p:sldId id="279" r:id="rId19"/>
    <p:sldId id="280" r:id="rId20"/>
    <p:sldId id="281" r:id="rId21"/>
    <p:sldId id="282" r:id="rId22"/>
    <p:sldId id="283" r:id="rId2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92" d="100"/>
          <a:sy n="92" d="100"/>
        </p:scale>
        <p:origin x="49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110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053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0790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9656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4740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221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0029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1936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226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6644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7295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4C8B5-A6E9-4EEC-893A-78D5BD8C4F8D}" type="datetimeFigureOut">
              <a:rPr lang="zh-CN" altLang="en-US" smtClean="0"/>
              <a:t>2022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B0D3D-53CA-4418-AC2C-7F16AA516A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3795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851419" y="194927"/>
            <a:ext cx="134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U2OS </a:t>
            </a:r>
            <a:r>
              <a:rPr lang="en-US" altLang="zh-CN" dirty="0" smtClean="0"/>
              <a:t>PCNA</a:t>
            </a:r>
            <a:endParaRPr lang="zh-CN" altLang="en-US" dirty="0"/>
          </a:p>
        </p:txBody>
      </p:sp>
      <p:sp>
        <p:nvSpPr>
          <p:cNvPr id="6" name="文本框 8"/>
          <p:cNvSpPr txBox="1"/>
          <p:nvPr/>
        </p:nvSpPr>
        <p:spPr>
          <a:xfrm rot="18594680">
            <a:off x="3939636" y="1284287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9"/>
          <p:cNvSpPr txBox="1"/>
          <p:nvPr/>
        </p:nvSpPr>
        <p:spPr>
          <a:xfrm rot="18594680">
            <a:off x="4092962" y="87224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10"/>
          <p:cNvSpPr txBox="1"/>
          <p:nvPr/>
        </p:nvSpPr>
        <p:spPr>
          <a:xfrm rot="18594680">
            <a:off x="4582191" y="87224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1"/>
          <p:cNvSpPr txBox="1"/>
          <p:nvPr/>
        </p:nvSpPr>
        <p:spPr>
          <a:xfrm rot="18594680">
            <a:off x="4942673" y="87224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2"/>
          <p:cNvSpPr txBox="1"/>
          <p:nvPr/>
        </p:nvSpPr>
        <p:spPr>
          <a:xfrm rot="18594680">
            <a:off x="5345963" y="87224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3851419" y="1844556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6163994" y="194927"/>
            <a:ext cx="1485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NNG PCNA</a:t>
            </a:r>
            <a:endParaRPr lang="zh-CN" altLang="en-US" dirty="0"/>
          </a:p>
        </p:txBody>
      </p:sp>
      <p:sp>
        <p:nvSpPr>
          <p:cNvPr id="13" name="文本框 8"/>
          <p:cNvSpPr txBox="1"/>
          <p:nvPr/>
        </p:nvSpPr>
        <p:spPr>
          <a:xfrm rot="18594680">
            <a:off x="6252211" y="1284287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9"/>
          <p:cNvSpPr txBox="1"/>
          <p:nvPr/>
        </p:nvSpPr>
        <p:spPr>
          <a:xfrm rot="18594680">
            <a:off x="6405537" y="87224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0"/>
          <p:cNvSpPr txBox="1"/>
          <p:nvPr/>
        </p:nvSpPr>
        <p:spPr>
          <a:xfrm rot="18594680">
            <a:off x="6759083" y="85988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1"/>
          <p:cNvSpPr txBox="1"/>
          <p:nvPr/>
        </p:nvSpPr>
        <p:spPr>
          <a:xfrm rot="18594680">
            <a:off x="7053924" y="85988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2"/>
          <p:cNvSpPr txBox="1"/>
          <p:nvPr/>
        </p:nvSpPr>
        <p:spPr>
          <a:xfrm rot="18594680">
            <a:off x="7348767" y="88459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6163994" y="1844556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4156991" y="2634506"/>
            <a:ext cx="1503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aos-2</a:t>
            </a:r>
            <a:r>
              <a:rPr lang="en-US" altLang="zh-CN" dirty="0" smtClean="0"/>
              <a:t> PCNA</a:t>
            </a:r>
            <a:endParaRPr lang="zh-CN" altLang="en-US" dirty="0"/>
          </a:p>
        </p:txBody>
      </p:sp>
      <p:sp>
        <p:nvSpPr>
          <p:cNvPr id="20" name="文本框 8"/>
          <p:cNvSpPr txBox="1"/>
          <p:nvPr/>
        </p:nvSpPr>
        <p:spPr>
          <a:xfrm rot="18594680">
            <a:off x="4489823" y="3089548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9"/>
          <p:cNvSpPr txBox="1"/>
          <p:nvPr/>
        </p:nvSpPr>
        <p:spPr>
          <a:xfrm rot="18594680">
            <a:off x="4643149" y="2677504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10"/>
          <p:cNvSpPr txBox="1"/>
          <p:nvPr/>
        </p:nvSpPr>
        <p:spPr>
          <a:xfrm rot="18594680">
            <a:off x="5132378" y="2677504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11"/>
          <p:cNvSpPr txBox="1"/>
          <p:nvPr/>
        </p:nvSpPr>
        <p:spPr>
          <a:xfrm rot="18594680">
            <a:off x="5492860" y="2677504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12"/>
          <p:cNvSpPr txBox="1"/>
          <p:nvPr/>
        </p:nvSpPr>
        <p:spPr>
          <a:xfrm rot="18594680">
            <a:off x="5896150" y="2677504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4401606" y="3649817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879830" y="64008"/>
            <a:ext cx="7505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Fig.3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472978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425377" y="54053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p38 in Fig. 5C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502378" y="1652994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5465563" y="1132072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5618889" y="7200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6006304" y="7200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6468600" y="7200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6871890" y="7200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98796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822705" y="1845362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38 in Fig. 5C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899706" y="3444303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4862891" y="2923381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5016217" y="251133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5403632" y="251133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5865928" y="251133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6269218" y="251133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43655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5864" y="114714"/>
            <a:ext cx="8524564" cy="6829549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791532" y="712753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pJNK</a:t>
            </a:r>
            <a:r>
              <a:rPr lang="en-US" altLang="zh-CN" dirty="0" smtClean="0"/>
              <a:t> in Fig. 5C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868533" y="2311694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4831718" y="1790772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4985044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5372459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5834755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6238045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849575" y="3143808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 smtClean="0"/>
              <a:t>JNK in Fig. 5C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4031562" y="3546045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8"/>
          <p:cNvSpPr txBox="1"/>
          <p:nvPr/>
        </p:nvSpPr>
        <p:spPr>
          <a:xfrm rot="18594680">
            <a:off x="3561192" y="4307957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9"/>
          <p:cNvSpPr txBox="1"/>
          <p:nvPr/>
        </p:nvSpPr>
        <p:spPr>
          <a:xfrm rot="18594680">
            <a:off x="3081687" y="4701215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0"/>
          <p:cNvSpPr txBox="1"/>
          <p:nvPr/>
        </p:nvSpPr>
        <p:spPr>
          <a:xfrm rot="18594680">
            <a:off x="3469102" y="4701215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1"/>
          <p:cNvSpPr txBox="1"/>
          <p:nvPr/>
        </p:nvSpPr>
        <p:spPr>
          <a:xfrm rot="18594680">
            <a:off x="3931398" y="4701215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2"/>
          <p:cNvSpPr txBox="1"/>
          <p:nvPr/>
        </p:nvSpPr>
        <p:spPr>
          <a:xfrm rot="18594680">
            <a:off x="4334688" y="4701215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372836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658" y="0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791532" y="712753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pAKT</a:t>
            </a:r>
            <a:r>
              <a:rPr lang="en-US" altLang="zh-CN" dirty="0" smtClean="0"/>
              <a:t> in Fig. 5C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868533" y="2311694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4935628" y="1790772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5109736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5507542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5834755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6238045" y="137872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66304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5217560" y="2260998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KT in Fig. 5C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5294561" y="3859939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8"/>
          <p:cNvSpPr txBox="1"/>
          <p:nvPr/>
        </p:nvSpPr>
        <p:spPr>
          <a:xfrm rot="18594680">
            <a:off x="5361656" y="3339017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9"/>
          <p:cNvSpPr txBox="1"/>
          <p:nvPr/>
        </p:nvSpPr>
        <p:spPr>
          <a:xfrm rot="18594680">
            <a:off x="5535764" y="29269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0"/>
          <p:cNvSpPr txBox="1"/>
          <p:nvPr/>
        </p:nvSpPr>
        <p:spPr>
          <a:xfrm rot="18594680">
            <a:off x="5933570" y="29269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1"/>
          <p:cNvSpPr txBox="1"/>
          <p:nvPr/>
        </p:nvSpPr>
        <p:spPr>
          <a:xfrm rot="18594680">
            <a:off x="6260783" y="29269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2"/>
          <p:cNvSpPr txBox="1"/>
          <p:nvPr/>
        </p:nvSpPr>
        <p:spPr>
          <a:xfrm rot="18594680">
            <a:off x="6664073" y="29269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321636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8397" y="0"/>
            <a:ext cx="837520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092869" y="515325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pAMPK</a:t>
            </a:r>
            <a:r>
              <a:rPr lang="en-US" altLang="zh-CN" dirty="0" smtClean="0"/>
              <a:t> in Fig. 5C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169870" y="2114266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5236965" y="1593344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5411073" y="11813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5808879" y="11813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6136092" y="11813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6539382" y="11813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722214" y="4376589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MPK in Fig. 5C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4594255" y="3668287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8"/>
          <p:cNvSpPr txBox="1"/>
          <p:nvPr/>
        </p:nvSpPr>
        <p:spPr>
          <a:xfrm rot="18594680">
            <a:off x="4661350" y="3147365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9"/>
          <p:cNvSpPr txBox="1"/>
          <p:nvPr/>
        </p:nvSpPr>
        <p:spPr>
          <a:xfrm rot="18594680">
            <a:off x="4835458" y="273532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0"/>
          <p:cNvSpPr txBox="1"/>
          <p:nvPr/>
        </p:nvSpPr>
        <p:spPr>
          <a:xfrm rot="18594680">
            <a:off x="5233264" y="273532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1"/>
          <p:cNvSpPr txBox="1"/>
          <p:nvPr/>
        </p:nvSpPr>
        <p:spPr>
          <a:xfrm rot="18594680">
            <a:off x="5560477" y="273532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2"/>
          <p:cNvSpPr txBox="1"/>
          <p:nvPr/>
        </p:nvSpPr>
        <p:spPr>
          <a:xfrm rot="18594680">
            <a:off x="5963767" y="273532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183516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4682" y="0"/>
            <a:ext cx="8379409" cy="6858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4359222" y="2142106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pmTOR</a:t>
            </a:r>
            <a:r>
              <a:rPr lang="en-US" altLang="zh-CN" dirty="0" smtClean="0"/>
              <a:t> in Fig. 5C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4436223" y="3741047"/>
            <a:ext cx="2092168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 rot="18594680">
            <a:off x="4503318" y="3220125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4680">
            <a:off x="4677426" y="280808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4680">
            <a:off x="5075232" y="280808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8594680">
            <a:off x="5402445" y="280808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594680">
            <a:off x="5805735" y="280808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899272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5055" y="145865"/>
            <a:ext cx="8254297" cy="6608226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494304" y="1279661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mTOR</a:t>
            </a:r>
            <a:r>
              <a:rPr lang="en-US" altLang="zh-CN" dirty="0" smtClean="0"/>
              <a:t> in Fig. 5C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571305" y="2878602"/>
            <a:ext cx="2092168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 rot="18594680">
            <a:off x="4638400" y="2357680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594680">
            <a:off x="4812508" y="194563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8594680">
            <a:off x="5210314" y="194563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4680">
            <a:off x="5537527" y="194563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4680">
            <a:off x="5940817" y="194563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054973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744" y="0"/>
            <a:ext cx="8439241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 rot="18595735">
            <a:off x="4362739" y="2067497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595735">
            <a:off x="4470104" y="1638431"/>
            <a:ext cx="22199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595735">
            <a:off x="4753529" y="1557020"/>
            <a:ext cx="2432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595735">
            <a:off x="5140573" y="1714549"/>
            <a:ext cx="1949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LXR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8595735">
            <a:off x="5463877" y="1581914"/>
            <a:ext cx="22387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REV-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5735">
            <a:off x="6098653" y="2045443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DIT4 KO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5735">
            <a:off x="6110403" y="1369984"/>
            <a:ext cx="27665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8595735">
            <a:off x="6432405" y="1312320"/>
            <a:ext cx="2910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595735">
            <a:off x="6794748" y="1537260"/>
            <a:ext cx="23236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LXR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595735">
            <a:off x="7101103" y="1402500"/>
            <a:ext cx="27151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REV-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118104" y="1137911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pmTOR</a:t>
            </a:r>
            <a:r>
              <a:rPr lang="en-US" altLang="zh-CN" dirty="0" smtClean="0"/>
              <a:t> in Fig. </a:t>
            </a:r>
            <a:r>
              <a:rPr lang="en-US" altLang="zh-CN" dirty="0" smtClean="0"/>
              <a:t>6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8756077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2417" y="0"/>
            <a:ext cx="8406384" cy="672998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 rot="18595735">
            <a:off x="4165311" y="2140234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595735">
            <a:off x="4272676" y="1711168"/>
            <a:ext cx="22199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595735">
            <a:off x="4556101" y="1629757"/>
            <a:ext cx="2432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8595735">
            <a:off x="4943145" y="1787286"/>
            <a:ext cx="1949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LXR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5735">
            <a:off x="5266449" y="1654651"/>
            <a:ext cx="22387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REV-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5735">
            <a:off x="5901225" y="2118180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DIT4 KO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8595735">
            <a:off x="5912975" y="1442721"/>
            <a:ext cx="27665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595735">
            <a:off x="6659666" y="1609997"/>
            <a:ext cx="23236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LXR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595735">
            <a:off x="6955630" y="1475237"/>
            <a:ext cx="27151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REV-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920676" y="1210648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mTOR</a:t>
            </a:r>
            <a:r>
              <a:rPr lang="en-US" altLang="zh-CN" dirty="0" smtClean="0"/>
              <a:t> </a:t>
            </a:r>
            <a:r>
              <a:rPr lang="en-US" altLang="zh-CN" dirty="0" smtClean="0"/>
              <a:t>in Fig. </a:t>
            </a:r>
            <a:r>
              <a:rPr lang="en-US" altLang="zh-CN" dirty="0" smtClean="0"/>
              <a:t>6C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 rot="18595735">
            <a:off x="6268023" y="1385053"/>
            <a:ext cx="2910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4383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955328" y="506654"/>
            <a:ext cx="1540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U2OS </a:t>
            </a:r>
            <a:r>
              <a:rPr lang="en-US" altLang="zh-CN" dirty="0" smtClean="0"/>
              <a:t>b-ACTIN</a:t>
            </a:r>
            <a:endParaRPr lang="zh-CN" altLang="en-US" dirty="0"/>
          </a:p>
        </p:txBody>
      </p:sp>
      <p:sp>
        <p:nvSpPr>
          <p:cNvPr id="6" name="文本框 8"/>
          <p:cNvSpPr txBox="1"/>
          <p:nvPr/>
        </p:nvSpPr>
        <p:spPr>
          <a:xfrm rot="18594680">
            <a:off x="4043545" y="1596014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9"/>
          <p:cNvSpPr txBox="1"/>
          <p:nvPr/>
        </p:nvSpPr>
        <p:spPr>
          <a:xfrm rot="18594680">
            <a:off x="4196871" y="11839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10"/>
          <p:cNvSpPr txBox="1"/>
          <p:nvPr/>
        </p:nvSpPr>
        <p:spPr>
          <a:xfrm rot="18594680">
            <a:off x="4686100" y="11839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1"/>
          <p:cNvSpPr txBox="1"/>
          <p:nvPr/>
        </p:nvSpPr>
        <p:spPr>
          <a:xfrm rot="18594680">
            <a:off x="5046582" y="11839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2"/>
          <p:cNvSpPr txBox="1"/>
          <p:nvPr/>
        </p:nvSpPr>
        <p:spPr>
          <a:xfrm rot="18594680">
            <a:off x="5449872" y="11839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3955328" y="2156283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6267903" y="506654"/>
            <a:ext cx="1784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NNG b-ACTIN</a:t>
            </a:r>
            <a:endParaRPr lang="zh-CN" altLang="en-US" dirty="0"/>
          </a:p>
        </p:txBody>
      </p:sp>
      <p:sp>
        <p:nvSpPr>
          <p:cNvPr id="13" name="文本框 8"/>
          <p:cNvSpPr txBox="1"/>
          <p:nvPr/>
        </p:nvSpPr>
        <p:spPr>
          <a:xfrm rot="18594680">
            <a:off x="6356120" y="1596014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9"/>
          <p:cNvSpPr txBox="1"/>
          <p:nvPr/>
        </p:nvSpPr>
        <p:spPr>
          <a:xfrm rot="18594680">
            <a:off x="6509446" y="11839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0"/>
          <p:cNvSpPr txBox="1"/>
          <p:nvPr/>
        </p:nvSpPr>
        <p:spPr>
          <a:xfrm rot="18594680">
            <a:off x="6862992" y="1171615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1"/>
          <p:cNvSpPr txBox="1"/>
          <p:nvPr/>
        </p:nvSpPr>
        <p:spPr>
          <a:xfrm rot="18594680">
            <a:off x="7157833" y="1171615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2"/>
          <p:cNvSpPr txBox="1"/>
          <p:nvPr/>
        </p:nvSpPr>
        <p:spPr>
          <a:xfrm rot="18594680">
            <a:off x="7452676" y="1196324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6267903" y="2156283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3358400" y="3006754"/>
            <a:ext cx="1650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aos-2</a:t>
            </a:r>
            <a:r>
              <a:rPr lang="en-US" altLang="zh-CN" dirty="0" smtClean="0"/>
              <a:t> b-ACTIN</a:t>
            </a:r>
            <a:endParaRPr lang="zh-CN" altLang="en-US" dirty="0"/>
          </a:p>
        </p:txBody>
      </p:sp>
      <p:sp>
        <p:nvSpPr>
          <p:cNvPr id="20" name="文本框 8"/>
          <p:cNvSpPr txBox="1"/>
          <p:nvPr/>
        </p:nvSpPr>
        <p:spPr>
          <a:xfrm rot="18594680">
            <a:off x="4043545" y="3499405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9"/>
          <p:cNvSpPr txBox="1"/>
          <p:nvPr/>
        </p:nvSpPr>
        <p:spPr>
          <a:xfrm rot="18594680">
            <a:off x="4196871" y="308736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10"/>
          <p:cNvSpPr txBox="1"/>
          <p:nvPr/>
        </p:nvSpPr>
        <p:spPr>
          <a:xfrm rot="18594680">
            <a:off x="4686100" y="308736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11"/>
          <p:cNvSpPr txBox="1"/>
          <p:nvPr/>
        </p:nvSpPr>
        <p:spPr>
          <a:xfrm rot="18594680">
            <a:off x="5046582" y="308736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12"/>
          <p:cNvSpPr txBox="1"/>
          <p:nvPr/>
        </p:nvSpPr>
        <p:spPr>
          <a:xfrm rot="18594680">
            <a:off x="5449872" y="308736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3955328" y="4059674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930598" y="271444"/>
            <a:ext cx="7505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Fig.3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2718247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 rot="18595735">
            <a:off x="4352348" y="2306488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595735">
            <a:off x="4459713" y="1877422"/>
            <a:ext cx="22199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595735">
            <a:off x="4743138" y="1796011"/>
            <a:ext cx="2432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595735">
            <a:off x="5130182" y="1953540"/>
            <a:ext cx="1949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LXR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8595735">
            <a:off x="5453486" y="1820905"/>
            <a:ext cx="22387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REV-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5735">
            <a:off x="6088262" y="2284434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DIT4 KO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5735">
            <a:off x="6100012" y="1608975"/>
            <a:ext cx="27665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8595735">
            <a:off x="6422014" y="1551311"/>
            <a:ext cx="2910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595735">
            <a:off x="6784357" y="1776251"/>
            <a:ext cx="23236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LXR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595735">
            <a:off x="7090712" y="1641491"/>
            <a:ext cx="27151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REV-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107713" y="1376902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S6 </a:t>
            </a:r>
            <a:r>
              <a:rPr lang="en-US" altLang="zh-CN" dirty="0" smtClean="0"/>
              <a:t>in Fig. </a:t>
            </a:r>
            <a:r>
              <a:rPr lang="en-US" altLang="zh-CN" dirty="0" smtClean="0"/>
              <a:t>6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0872540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 rot="18595735">
            <a:off x="4321175" y="1527169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595735">
            <a:off x="4428540" y="1098103"/>
            <a:ext cx="22199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595735">
            <a:off x="4711965" y="1016692"/>
            <a:ext cx="2432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595735">
            <a:off x="5099009" y="1174221"/>
            <a:ext cx="1949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LXR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8595735">
            <a:off x="5422313" y="1041586"/>
            <a:ext cx="22387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REV-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5735">
            <a:off x="6057089" y="1505115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DIT4 KO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5735">
            <a:off x="6068839" y="829656"/>
            <a:ext cx="27665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8595735">
            <a:off x="6432405" y="771992"/>
            <a:ext cx="2910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595735">
            <a:off x="6971395" y="996932"/>
            <a:ext cx="23236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LXR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595735">
            <a:off x="7267359" y="862172"/>
            <a:ext cx="27151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REV-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076540" y="597583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6 </a:t>
            </a:r>
            <a:r>
              <a:rPr lang="en-US" altLang="zh-CN" dirty="0" smtClean="0"/>
              <a:t>in Fig. </a:t>
            </a:r>
            <a:r>
              <a:rPr lang="en-US" altLang="zh-CN" dirty="0" smtClean="0"/>
              <a:t>6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5990715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 rot="18595735">
            <a:off x="4352348" y="2306488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595735">
            <a:off x="4459713" y="1877422"/>
            <a:ext cx="22199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595735">
            <a:off x="4743138" y="1796011"/>
            <a:ext cx="2432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595735">
            <a:off x="5130182" y="1953540"/>
            <a:ext cx="19492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LXR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8595735">
            <a:off x="5453486" y="1820905"/>
            <a:ext cx="22387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REV-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5735">
            <a:off x="6088262" y="2284434"/>
            <a:ext cx="1028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DIT4 KO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5735">
            <a:off x="6100012" y="1608975"/>
            <a:ext cx="27665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O, </a:t>
            </a:r>
            <a:r>
              <a:rPr lang="en-US" altLang="zh-CN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8595735">
            <a:off x="6784357" y="1776251"/>
            <a:ext cx="23236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LXR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595735">
            <a:off x="7090712" y="1641491"/>
            <a:ext cx="27151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REV-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107713" y="1376902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-ACTIN </a:t>
            </a:r>
            <a:r>
              <a:rPr lang="en-US" altLang="zh-CN" dirty="0" smtClean="0"/>
              <a:t>in Fig. </a:t>
            </a:r>
            <a:r>
              <a:rPr lang="en-US" altLang="zh-CN" dirty="0" smtClean="0"/>
              <a:t>6C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 rot="18595735">
            <a:off x="6422014" y="1551311"/>
            <a:ext cx="29102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DIT4 KO,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agonist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5165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9196" y="11092"/>
            <a:ext cx="8406384" cy="6729984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5687367" y="1112286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HOS-MNNG CC3 in Fig.S2B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5605494" y="2827029"/>
            <a:ext cx="2413592" cy="8473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 rot="18594680">
            <a:off x="5571575" y="2315275"/>
            <a:ext cx="928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 rot="18594680">
            <a:off x="5728238" y="1901671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94680">
            <a:off x="6115653" y="1901671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 rot="18594680">
            <a:off x="6577949" y="1901671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 rot="18594680">
            <a:off x="6981239" y="1901671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3068458" y="2827029"/>
            <a:ext cx="2413592" cy="8473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 rot="18594680">
            <a:off x="3075194" y="2267211"/>
            <a:ext cx="928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 rot="18594680">
            <a:off x="3231857" y="1853607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8594680">
            <a:off x="3619272" y="1853607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 rot="18594680">
            <a:off x="4081568" y="1853607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 rot="18594680">
            <a:off x="4484858" y="1853607"/>
            <a:ext cx="199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472315" y="1112287"/>
            <a:ext cx="2462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U2OS CC3 in Fig.S2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438799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464151" y="825369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U2OS C3 in Fig.S2B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239491" y="2665439"/>
            <a:ext cx="1963882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4094791" y="2144517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4248117" y="17324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4635532" y="17324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5097828" y="17324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5501118" y="1732473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569884" y="857566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HOS-MNNG C3 in Fig.S2B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6345224" y="2697636"/>
            <a:ext cx="1963882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8"/>
          <p:cNvSpPr txBox="1"/>
          <p:nvPr/>
        </p:nvSpPr>
        <p:spPr>
          <a:xfrm rot="18594680">
            <a:off x="6200524" y="2176714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9"/>
          <p:cNvSpPr txBox="1"/>
          <p:nvPr/>
        </p:nvSpPr>
        <p:spPr>
          <a:xfrm rot="18594680">
            <a:off x="6353850" y="17646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0"/>
          <p:cNvSpPr txBox="1"/>
          <p:nvPr/>
        </p:nvSpPr>
        <p:spPr>
          <a:xfrm rot="18594680">
            <a:off x="6741265" y="17646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1"/>
          <p:cNvSpPr txBox="1"/>
          <p:nvPr/>
        </p:nvSpPr>
        <p:spPr>
          <a:xfrm rot="18594680">
            <a:off x="7203561" y="17646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2"/>
          <p:cNvSpPr txBox="1"/>
          <p:nvPr/>
        </p:nvSpPr>
        <p:spPr>
          <a:xfrm rot="18594680">
            <a:off x="7606851" y="176467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54908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308287" y="1022796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U2OS BAX in Fig.S2B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4083627" y="2862866"/>
            <a:ext cx="1963882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8"/>
          <p:cNvSpPr txBox="1"/>
          <p:nvPr/>
        </p:nvSpPr>
        <p:spPr>
          <a:xfrm rot="18594680">
            <a:off x="3938927" y="2341944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9"/>
          <p:cNvSpPr txBox="1"/>
          <p:nvPr/>
        </p:nvSpPr>
        <p:spPr>
          <a:xfrm rot="18594680">
            <a:off x="4092253" y="19299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0"/>
          <p:cNvSpPr txBox="1"/>
          <p:nvPr/>
        </p:nvSpPr>
        <p:spPr>
          <a:xfrm rot="18594680">
            <a:off x="4479668" y="19299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1"/>
          <p:cNvSpPr txBox="1"/>
          <p:nvPr/>
        </p:nvSpPr>
        <p:spPr>
          <a:xfrm rot="18594680">
            <a:off x="4941964" y="19299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2"/>
          <p:cNvSpPr txBox="1"/>
          <p:nvPr/>
        </p:nvSpPr>
        <p:spPr>
          <a:xfrm rot="18594680">
            <a:off x="5345254" y="192990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414020" y="1054993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HOS-MNNG BAX in Fig.S2B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6189360" y="2895063"/>
            <a:ext cx="2048968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8"/>
          <p:cNvSpPr txBox="1"/>
          <p:nvPr/>
        </p:nvSpPr>
        <p:spPr>
          <a:xfrm rot="18594680">
            <a:off x="6044660" y="2374141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9"/>
          <p:cNvSpPr txBox="1"/>
          <p:nvPr/>
        </p:nvSpPr>
        <p:spPr>
          <a:xfrm rot="18594680">
            <a:off x="6197986" y="196209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0"/>
          <p:cNvSpPr txBox="1"/>
          <p:nvPr/>
        </p:nvSpPr>
        <p:spPr>
          <a:xfrm rot="18594680">
            <a:off x="6585401" y="196209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1"/>
          <p:cNvSpPr txBox="1"/>
          <p:nvPr/>
        </p:nvSpPr>
        <p:spPr>
          <a:xfrm rot="18594680">
            <a:off x="7047697" y="196209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2"/>
          <p:cNvSpPr txBox="1"/>
          <p:nvPr/>
        </p:nvSpPr>
        <p:spPr>
          <a:xfrm rot="18594680">
            <a:off x="7450987" y="1962097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07800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9454" y="0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609624" y="201914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U2OS b-ACTIN in Fig.S2B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277079" y="2041984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4240264" y="1521062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4393590" y="110901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4781005" y="110901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5243301" y="110901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5646591" y="1109018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9014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6718979" y="233086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HOS-MNNG b-ACTIN in Fig.S2B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6386434" y="2073156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6349619" y="1552234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6502945" y="114019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6890360" y="114019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7352656" y="114019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7755946" y="1140190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67755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410" y="168800"/>
            <a:ext cx="7960174" cy="6372758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814139" y="1376087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-ACTIN in Fig. 5C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481594" y="3216157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8"/>
          <p:cNvSpPr txBox="1"/>
          <p:nvPr/>
        </p:nvSpPr>
        <p:spPr>
          <a:xfrm rot="18594680">
            <a:off x="5444779" y="2695235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9"/>
          <p:cNvSpPr txBox="1"/>
          <p:nvPr/>
        </p:nvSpPr>
        <p:spPr>
          <a:xfrm rot="18594680">
            <a:off x="5598105" y="228319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0"/>
          <p:cNvSpPr txBox="1"/>
          <p:nvPr/>
        </p:nvSpPr>
        <p:spPr>
          <a:xfrm rot="18594680">
            <a:off x="5985520" y="228319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1"/>
          <p:cNvSpPr txBox="1"/>
          <p:nvPr/>
        </p:nvSpPr>
        <p:spPr>
          <a:xfrm rot="18594680">
            <a:off x="6447816" y="228319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2"/>
          <p:cNvSpPr txBox="1"/>
          <p:nvPr/>
        </p:nvSpPr>
        <p:spPr>
          <a:xfrm rot="18594680">
            <a:off x="6851106" y="2283191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00748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08" y="64008"/>
            <a:ext cx="8406384" cy="672998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5259123" y="120471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ERK1/2 in Fig. 5C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336124" y="1719412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8"/>
          <p:cNvSpPr txBox="1"/>
          <p:nvPr/>
        </p:nvSpPr>
        <p:spPr>
          <a:xfrm rot="18594680">
            <a:off x="5299309" y="1198490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9"/>
          <p:cNvSpPr txBox="1"/>
          <p:nvPr/>
        </p:nvSpPr>
        <p:spPr>
          <a:xfrm rot="18594680">
            <a:off x="5452635" y="78644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0"/>
          <p:cNvSpPr txBox="1"/>
          <p:nvPr/>
        </p:nvSpPr>
        <p:spPr>
          <a:xfrm rot="18594680">
            <a:off x="5840050" y="78644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1"/>
          <p:cNvSpPr txBox="1"/>
          <p:nvPr/>
        </p:nvSpPr>
        <p:spPr>
          <a:xfrm rot="18594680">
            <a:off x="6302346" y="78644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2"/>
          <p:cNvSpPr txBox="1"/>
          <p:nvPr/>
        </p:nvSpPr>
        <p:spPr>
          <a:xfrm rot="18594680">
            <a:off x="6705636" y="78644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398597" y="2085191"/>
            <a:ext cx="32459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ERK1/2 in Fig. 5C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4475598" y="3684132"/>
            <a:ext cx="2286000" cy="4468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8"/>
          <p:cNvSpPr txBox="1"/>
          <p:nvPr/>
        </p:nvSpPr>
        <p:spPr>
          <a:xfrm rot="18594680">
            <a:off x="4438783" y="3163210"/>
            <a:ext cx="932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9"/>
          <p:cNvSpPr txBox="1"/>
          <p:nvPr/>
        </p:nvSpPr>
        <p:spPr>
          <a:xfrm rot="18594680">
            <a:off x="4592109" y="275116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b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0"/>
          <p:cNvSpPr txBox="1"/>
          <p:nvPr/>
        </p:nvSpPr>
        <p:spPr>
          <a:xfrm rot="18594680">
            <a:off x="4979524" y="275116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Rg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1"/>
          <p:cNvSpPr txBox="1"/>
          <p:nvPr/>
        </p:nvSpPr>
        <p:spPr>
          <a:xfrm rot="18594680">
            <a:off x="5441820" y="275116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XR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2"/>
          <p:cNvSpPr txBox="1"/>
          <p:nvPr/>
        </p:nvSpPr>
        <p:spPr>
          <a:xfrm rot="18594680">
            <a:off x="5845110" y="2751166"/>
            <a:ext cx="2006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V-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Ba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gonis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3952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</TotalTime>
  <Words>574</Words>
  <Application>Microsoft Office PowerPoint</Application>
  <PresentationFormat>宽屏</PresentationFormat>
  <Paragraphs>219</Paragraphs>
  <Slides>2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2</vt:i4>
      </vt:variant>
    </vt:vector>
  </HeadingPairs>
  <TitlesOfParts>
    <vt:vector size="27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o</dc:creator>
  <cp:lastModifiedBy>Tao</cp:lastModifiedBy>
  <cp:revision>12</cp:revision>
  <dcterms:created xsi:type="dcterms:W3CDTF">2022-08-01T08:43:54Z</dcterms:created>
  <dcterms:modified xsi:type="dcterms:W3CDTF">2022-11-19T05:58:05Z</dcterms:modified>
</cp:coreProperties>
</file>